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78" d="100"/>
          <a:sy n="78" d="100"/>
        </p:scale>
        <p:origin x="89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5187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3764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149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56738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6100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39085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130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02602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27367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79037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2776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10558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5840" y="697218"/>
            <a:ext cx="8222369" cy="5985835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195444" y="160544"/>
            <a:ext cx="3469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1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7289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391886" y="505099"/>
            <a:ext cx="8352064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1. Definition for portosystemic shunts</a:t>
            </a:r>
            <a:endParaRPr lang="ja-JP" altLang="ja-JP" sz="14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he para-esophageal veins (Para-V) (arrows) denote azygos veins and enter the superior vena cava. The para-umbilical vein connects from the portal vein to systemic circulation. The </a:t>
            </a:r>
            <a:r>
              <a:rPr lang="en-US" altLang="ja-JP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astrorenal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shunt (arrow head) connects from the left gastric vein or </a:t>
            </a:r>
            <a:r>
              <a:rPr lang="en-US" altLang="ja-JP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ortogastric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short gastric veins to the left renal vein. </a:t>
            </a:r>
            <a:endParaRPr lang="ja-JP" altLang="ja-JP" sz="1400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38865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67</Words>
  <Application>Microsoft Office PowerPoint</Application>
  <PresentationFormat>画面に合わせる (4:3)</PresentationFormat>
  <Paragraphs>3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9" baseType="lpstr">
      <vt:lpstr>ＭＳ Ｐゴシック</vt:lpstr>
      <vt:lpstr>ＭＳ 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重福 隆太</dc:creator>
  <cp:lastModifiedBy>重福 隆太</cp:lastModifiedBy>
  <cp:revision>4</cp:revision>
  <dcterms:created xsi:type="dcterms:W3CDTF">2021-10-17T09:25:07Z</dcterms:created>
  <dcterms:modified xsi:type="dcterms:W3CDTF">2021-12-23T16:40:33Z</dcterms:modified>
</cp:coreProperties>
</file>